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670675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DC20D7-FC4D-49E1-8642-E8EA3442583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8482B5-1369-4BB3-99F3-798876B94A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5115A2-3AA1-4087-9774-6489749014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C92268-CD46-4F5E-A6E7-B11E0119B60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719025-5B5F-4661-8F2D-9FD409FCC7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A25782-696C-4C9E-81E8-A862500D9A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89377-DB7A-4C56-A5BF-DD2A6D2025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3862B-B22A-413F-976A-7A3BB683B4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3C9EB5-0437-403F-810A-A92ACA13AD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6F8660-A295-444A-9B12-BED0574B37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360D20-C878-495C-BB0A-2F8D0B30A8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A384CE-4E4F-487A-9254-967DC51A54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D297FB-560B-4692-A25A-64A1C0803EA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4920" y="711360"/>
            <a:ext cx="9159840" cy="5302440"/>
            <a:chOff x="34920" y="711360"/>
            <a:chExt cx="9159840" cy="530244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0" t="0" r="3633" b="0"/>
            <a:stretch/>
          </p:blipFill>
          <p:spPr>
            <a:xfrm>
              <a:off x="71280" y="3403440"/>
              <a:ext cx="9055080" cy="2320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71280" y="5551560"/>
              <a:ext cx="8533080" cy="216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57240" y="5538960"/>
              <a:ext cx="853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6912000" y="3149640"/>
              <a:ext cx="7128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7842240" y="2565360"/>
              <a:ext cx="7128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7999560" y="2154240"/>
              <a:ext cx="7128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8158320" y="1344600"/>
              <a:ext cx="7128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8086680" y="2144880"/>
              <a:ext cx="360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2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7940520" y="2532240"/>
              <a:ext cx="412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2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7031160" y="3121200"/>
              <a:ext cx="361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2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8256600" y="1346040"/>
              <a:ext cx="361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T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784600" y="3152880"/>
              <a:ext cx="71280" cy="144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7305840" y="2562120"/>
              <a:ext cx="71280" cy="144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7493040" y="3151080"/>
              <a:ext cx="71280" cy="144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7927920" y="2354400"/>
              <a:ext cx="71640" cy="144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8058240" y="1951200"/>
              <a:ext cx="71280" cy="144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8172360" y="938160"/>
              <a:ext cx="71640" cy="144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8172360" y="1141560"/>
              <a:ext cx="71640" cy="144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8272440" y="763560"/>
              <a:ext cx="71640" cy="144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8359920" y="2570040"/>
              <a:ext cx="71280" cy="144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8447040" y="2114640"/>
              <a:ext cx="71640" cy="144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8474040" y="3146400"/>
              <a:ext cx="71640" cy="144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5583240" y="3137040"/>
              <a:ext cx="576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F-</a:t>
              </a:r>
              <a:r>
                <a:rPr b="1" lang="el-G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κ</a:t>
              </a: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6073920" y="2949480"/>
              <a:ext cx="576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F-</a:t>
              </a:r>
              <a:r>
                <a:rPr b="1" lang="el-G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κ</a:t>
              </a: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871720" y="3117960"/>
              <a:ext cx="277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5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6558120" y="2575080"/>
              <a:ext cx="360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P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7319880" y="2733840"/>
              <a:ext cx="360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P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6342120" y="2782800"/>
              <a:ext cx="576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GR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7122960" y="2949480"/>
              <a:ext cx="471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CF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4795920" y="2978280"/>
              <a:ext cx="360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P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7405560" y="2532240"/>
              <a:ext cx="360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C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8028000" y="2340000"/>
              <a:ext cx="360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C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7593120" y="3122640"/>
              <a:ext cx="360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P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8272440" y="900000"/>
              <a:ext cx="360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C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8172360" y="1908000"/>
              <a:ext cx="360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P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8286840" y="1116000"/>
              <a:ext cx="360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C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8459640" y="2532240"/>
              <a:ext cx="360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C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8388360" y="711360"/>
              <a:ext cx="576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H4TF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8561520" y="2100240"/>
              <a:ext cx="360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P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8589960" y="3137040"/>
              <a:ext cx="360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U.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7450200" y="2360520"/>
              <a:ext cx="71280" cy="144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7550280" y="2330280"/>
              <a:ext cx="360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C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7234200" y="2763720"/>
              <a:ext cx="71640" cy="144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7032600" y="2973240"/>
              <a:ext cx="71640" cy="144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6472080" y="2593800"/>
              <a:ext cx="71640" cy="144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6256440" y="2800440"/>
              <a:ext cx="71280" cy="144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5986440" y="2973240"/>
              <a:ext cx="71640" cy="144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5511960" y="3151080"/>
              <a:ext cx="71280" cy="144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4724280" y="2992320"/>
              <a:ext cx="71640" cy="144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116000" y="3149640"/>
              <a:ext cx="7128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206360" y="3122640"/>
              <a:ext cx="463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EA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474920" y="1576440"/>
              <a:ext cx="71280" cy="144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692360" y="3152880"/>
              <a:ext cx="71280" cy="144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1571760" y="1538280"/>
              <a:ext cx="2775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5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1779480" y="3127320"/>
              <a:ext cx="360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P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711360" y="1967040"/>
              <a:ext cx="7128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814320" y="1940040"/>
              <a:ext cx="463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ML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57200" y="2543040"/>
              <a:ext cx="463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193680" y="3149640"/>
              <a:ext cx="7128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97000" y="3122640"/>
              <a:ext cx="463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ML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309600" y="2976480"/>
              <a:ext cx="71280" cy="144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12920" y="2949480"/>
              <a:ext cx="463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X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352440" y="2556000"/>
              <a:ext cx="7128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336600" y="2786040"/>
              <a:ext cx="7128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441360" y="2773440"/>
              <a:ext cx="463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IR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711360" y="2179800"/>
              <a:ext cx="7128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809640" y="2166840"/>
              <a:ext cx="463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IRF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798480" y="1733400"/>
              <a:ext cx="11797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AT(1and 5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696960" y="1762200"/>
              <a:ext cx="7128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708120" y="1560600"/>
              <a:ext cx="7128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811080" y="1533600"/>
              <a:ext cx="463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EF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1111320" y="2976480"/>
              <a:ext cx="71280" cy="144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1128600" y="2949480"/>
              <a:ext cx="463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E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1120680" y="2789280"/>
              <a:ext cx="7164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1166760" y="2762280"/>
              <a:ext cx="463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TEL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1125360" y="2549520"/>
              <a:ext cx="7164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1071720" y="2522520"/>
              <a:ext cx="1484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TAT (5A and 6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1127160" y="2343240"/>
              <a:ext cx="7128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1144440" y="2316240"/>
              <a:ext cx="846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ETS16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1425600" y="2171880"/>
              <a:ext cx="7128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500120" y="2158920"/>
              <a:ext cx="463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X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3932280" y="3144960"/>
              <a:ext cx="7128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035600" y="3117960"/>
              <a:ext cx="1328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GEN_INI1-2-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3936960" y="2976480"/>
              <a:ext cx="71640" cy="144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4040280" y="2949480"/>
              <a:ext cx="463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7800840" y="2967120"/>
              <a:ext cx="7164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7885080" y="2949480"/>
              <a:ext cx="849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USF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7797960" y="2765520"/>
              <a:ext cx="7128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7881840" y="2747880"/>
              <a:ext cx="708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HRHI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8142120" y="1757520"/>
              <a:ext cx="7164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8226360" y="1739880"/>
              <a:ext cx="866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P2ALPH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8142120" y="1536840"/>
              <a:ext cx="71640" cy="144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8226360" y="1519200"/>
              <a:ext cx="866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ZF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8402760" y="2333520"/>
              <a:ext cx="71280" cy="144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8486640" y="2316240"/>
              <a:ext cx="708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HRHI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4067280" y="3749760"/>
              <a:ext cx="4464000" cy="0"/>
            </a:xfrm>
            <a:prstGeom prst="line">
              <a:avLst/>
            </a:prstGeom>
            <a:ln w="38160">
              <a:solidFill>
                <a:srgbClr val="333399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7680240" y="3427560"/>
              <a:ext cx="865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ECR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581040" y="3419640"/>
              <a:ext cx="865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ECR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0" name=""/>
            <p:cNvGrpSpPr/>
            <p:nvPr/>
          </p:nvGrpSpPr>
          <p:grpSpPr>
            <a:xfrm>
              <a:off x="34920" y="5537160"/>
              <a:ext cx="8567640" cy="476640"/>
              <a:chOff x="34920" y="5537160"/>
              <a:chExt cx="8567640" cy="476640"/>
            </a:xfrm>
          </p:grpSpPr>
          <p:sp>
            <p:nvSpPr>
              <p:cNvPr id="141" name=""/>
              <p:cNvSpPr/>
              <p:nvPr/>
            </p:nvSpPr>
            <p:spPr>
              <a:xfrm>
                <a:off x="34920" y="5538600"/>
                <a:ext cx="8567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8251920" y="5543640"/>
                <a:ext cx="0" cy="22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6391080" y="5540400"/>
                <a:ext cx="0" cy="22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7947000" y="5734080"/>
                <a:ext cx="647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5958000" y="5734080"/>
                <a:ext cx="836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25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4518000" y="5537160"/>
                <a:ext cx="0" cy="22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4092480" y="5730840"/>
                <a:ext cx="836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5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784080" y="5543640"/>
                <a:ext cx="0" cy="22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355680" y="5737320"/>
                <a:ext cx="836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10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2647800" y="5543640"/>
                <a:ext cx="0" cy="22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2203560" y="5730840"/>
                <a:ext cx="836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75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6-10T14:44:31Z</dcterms:created>
  <dc:creator>henslen</dc:creator>
  <dc:description/>
  <dc:language>en-US</dc:language>
  <cp:lastModifiedBy>henslen</cp:lastModifiedBy>
  <dcterms:modified xsi:type="dcterms:W3CDTF">2006-06-14T10:16:55Z</dcterms:modified>
  <cp:revision>4</cp:revision>
  <dc:subject/>
  <dc:title>Diapositive 1</dc:title>
</cp:coreProperties>
</file>